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66" r:id="rId2"/>
    <p:sldId id="267" r:id="rId3"/>
    <p:sldId id="274" r:id="rId4"/>
    <p:sldId id="280" r:id="rId5"/>
    <p:sldId id="292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1121" autoAdjust="0"/>
  </p:normalViewPr>
  <p:slideViewPr>
    <p:cSldViewPr snapToGrid="0">
      <p:cViewPr varScale="1">
        <p:scale>
          <a:sx n="73" d="100"/>
          <a:sy n="73" d="100"/>
        </p:scale>
        <p:origin x="404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0ECEE3A-B8CF-4592-AADB-3A5D0A1EFEA9}" type="datetimeFigureOut">
              <a:rPr lang="en-US" smtClean="0"/>
              <a:t>10/3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B4A7D4C-F39B-45BC-9E6B-6D00F566E9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62883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B4A7D4C-F39B-45BC-9E6B-6D00F566E9F3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748525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FC2AC8-C3A3-4CBB-8CD6-19768BF645B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85A6E1D-635C-4484-B544-A33C114C566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15C2CC-089C-45F8-9C55-9508A3FC9C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1CD37-8DC6-4A5E-A63B-79D145A93481}" type="datetimeFigureOut">
              <a:rPr lang="en-US" smtClean="0"/>
              <a:t>10/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68124C-48D1-4F96-A682-64252924BE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DDF663-8697-477A-AB2D-3FD703FEAA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2CADFA-28C3-44FC-8138-728C77836E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62022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784825-E464-4F8B-80BD-F526640072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86EFCB0-330C-4E1B-B514-07A91061076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084744-5E84-4E05-865A-AB38B6031C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1CD37-8DC6-4A5E-A63B-79D145A93481}" type="datetimeFigureOut">
              <a:rPr lang="en-US" smtClean="0"/>
              <a:t>10/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50F2FA-1DD8-4938-B77E-E0949F3510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5A61EC-BD2E-4AA6-9DFF-8B592C24F6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2CADFA-28C3-44FC-8138-728C77836E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34570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A7621BE-A8BA-4A3B-A27F-38FC223F514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41731EB-9D46-4D22-B5E7-83753428F03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ED80AD-541B-48C8-8EE5-17334897FB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1CD37-8DC6-4A5E-A63B-79D145A93481}" type="datetimeFigureOut">
              <a:rPr lang="en-US" smtClean="0"/>
              <a:t>10/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D3B175-0F7E-4534-AED9-985345D796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C6EF82-A9FE-41CF-8ADC-E04A391C52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2CADFA-28C3-44FC-8138-728C77836E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12876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7BF311-C1FC-4AE7-9F7A-D0557AC6DF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55B8EFD-CDFA-4E0F-BB68-C32926E394B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CAC22D-389D-4942-BDDE-27C4479604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1CD37-8DC6-4A5E-A63B-79D145A93481}" type="datetimeFigureOut">
              <a:rPr lang="en-US" smtClean="0"/>
              <a:t>10/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85B567-6731-46C1-9CE2-274B0BA893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4CE22D-9BB9-4BC1-938D-752F6C0550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2CADFA-28C3-44FC-8138-728C77836E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6C65C0-9E9B-4F67-BD7F-B5038FFB03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6EB3D8F-2AFB-4975-9E38-4A602E0A42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5D91F4-4A67-4B68-8E48-F9C5E033B0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1CD37-8DC6-4A5E-A63B-79D145A93481}" type="datetimeFigureOut">
              <a:rPr lang="en-US" smtClean="0"/>
              <a:t>10/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DBECE0-E261-42E7-8E84-87E40A1258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D4AF1A-D0E2-4AA3-A97F-45E19CD78C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2CADFA-28C3-44FC-8138-728C77836E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12738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E903D2-B606-4015-B900-505C3C4B51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AAE1329-7971-43D2-B412-7AC2752246A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286145E-118E-4BD8-B3D9-0BF07AE872C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3C2A38C-BD96-48C3-AB5B-E05242FB93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1CD37-8DC6-4A5E-A63B-79D145A93481}" type="datetimeFigureOut">
              <a:rPr lang="en-US" smtClean="0"/>
              <a:t>10/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D7917EE-073C-4178-ABA1-FAFAA23AD7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EDD8E53-9307-4A85-A3E3-32AC79C038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2CADFA-28C3-44FC-8138-728C77836E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8260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BFB8F3-C741-4E1F-89F7-D55E65992F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5FA1B5B-E426-437E-BF9F-A47A166FA4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6D18514-69E0-4708-BA31-DCECD3674F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F81CA22-CEF0-4400-A28F-690BA72F630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070D5D0-A57C-41BC-8E51-BDA07ACBEF3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E5CD3C5-6839-41E3-95AA-EE04BB2334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1CD37-8DC6-4A5E-A63B-79D145A93481}" type="datetimeFigureOut">
              <a:rPr lang="en-US" smtClean="0"/>
              <a:t>10/3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3B1E68B-9893-408B-BE65-5F72F39A3C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063145C-713F-4F3A-AB50-FFC8634BA4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2CADFA-28C3-44FC-8138-728C77836E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46799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CF0249-EE2D-48D4-A4AC-D8E78FC040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F406231-37AA-4DF1-8CF8-AE190CE025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1CD37-8DC6-4A5E-A63B-79D145A93481}" type="datetimeFigureOut">
              <a:rPr lang="en-US" smtClean="0"/>
              <a:t>10/3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3333D59-4963-4C71-B9D9-CDE3C7FF52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3147B3D-3D6F-4370-925F-69D5AC3208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2CADFA-28C3-44FC-8138-728C77836E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11423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970AD61-2A92-462B-8A72-02C2136885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1CD37-8DC6-4A5E-A63B-79D145A93481}" type="datetimeFigureOut">
              <a:rPr lang="en-US" smtClean="0"/>
              <a:t>10/3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401C98A-A4C2-4FDD-B132-9ECADEF092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935E256-4ACD-429D-915B-2ACEA6F8B5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2CADFA-28C3-44FC-8138-728C77836E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60291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DBA434-04CB-4D59-B153-49102D701F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6C6696-125B-4312-B81C-A958F04ED4D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9628A77-EE20-4CF8-A625-3126873E3F9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BA59D1F-08AE-4F83-B567-0C882EA5CE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1CD37-8DC6-4A5E-A63B-79D145A93481}" type="datetimeFigureOut">
              <a:rPr lang="en-US" smtClean="0"/>
              <a:t>10/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28E2348-4385-4AFF-B79C-1ED0FDF105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AF05A9C-660F-4ADD-AC78-4918784472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2CADFA-28C3-44FC-8138-728C77836E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58700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9E2933-F67B-403C-8D4B-16CF442521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78AC1CE-D2D7-49C0-8753-569E12595EE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7E035D1-C601-4311-89BD-7DEADFCCC98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8DCE821-7803-45D6-B8A8-BE2D11A61F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1CD37-8DC6-4A5E-A63B-79D145A93481}" type="datetimeFigureOut">
              <a:rPr lang="en-US" smtClean="0"/>
              <a:t>10/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0479B67-23DE-4769-9F35-2994FA000A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A9D43E2-20EB-44B9-A250-F3E7FD55E3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2CADFA-28C3-44FC-8138-728C77836E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14633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1AEE812-979A-43A4-9B72-7659C1E4A7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5FF745D-9A86-4493-9594-AB888FF9BCD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DFEF943-FF96-4BB1-B831-AB8ED591F5E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D1CD37-8DC6-4A5E-A63B-79D145A93481}" type="datetimeFigureOut">
              <a:rPr lang="en-US" smtClean="0"/>
              <a:t>10/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215C986-845B-4261-B021-FB68FBF4F1E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28B8B4E-F7C7-4AA1-9DB6-9DE5803E332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2CADFA-28C3-44FC-8138-728C77836E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85849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4">
            <a:extLst>
              <a:ext uri="{FF2B5EF4-FFF2-40B4-BE49-F238E27FC236}">
                <a16:creationId xmlns:a16="http://schemas.microsoft.com/office/drawing/2014/main" id="{E08649A9-F922-4274-9FB9-9E262C6BCE5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90837777"/>
              </p:ext>
            </p:extLst>
          </p:nvPr>
        </p:nvGraphicFramePr>
        <p:xfrm>
          <a:off x="110412" y="566702"/>
          <a:ext cx="11971176" cy="360880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544869">
                  <a:extLst>
                    <a:ext uri="{9D8B030D-6E8A-4147-A177-3AD203B41FA5}">
                      <a16:colId xmlns:a16="http://schemas.microsoft.com/office/drawing/2014/main" val="2663020636"/>
                    </a:ext>
                  </a:extLst>
                </a:gridCol>
                <a:gridCol w="1115913">
                  <a:extLst>
                    <a:ext uri="{9D8B030D-6E8A-4147-A177-3AD203B41FA5}">
                      <a16:colId xmlns:a16="http://schemas.microsoft.com/office/drawing/2014/main" val="3312365198"/>
                    </a:ext>
                  </a:extLst>
                </a:gridCol>
                <a:gridCol w="830491">
                  <a:extLst>
                    <a:ext uri="{9D8B030D-6E8A-4147-A177-3AD203B41FA5}">
                      <a16:colId xmlns:a16="http://schemas.microsoft.com/office/drawing/2014/main" val="2112926917"/>
                    </a:ext>
                  </a:extLst>
                </a:gridCol>
                <a:gridCol w="1329030">
                  <a:extLst>
                    <a:ext uri="{9D8B030D-6E8A-4147-A177-3AD203B41FA5}">
                      <a16:colId xmlns:a16="http://schemas.microsoft.com/office/drawing/2014/main" val="1275774156"/>
                    </a:ext>
                  </a:extLst>
                </a:gridCol>
                <a:gridCol w="1126964">
                  <a:extLst>
                    <a:ext uri="{9D8B030D-6E8A-4147-A177-3AD203B41FA5}">
                      <a16:colId xmlns:a16="http://schemas.microsoft.com/office/drawing/2014/main" val="1471504787"/>
                    </a:ext>
                  </a:extLst>
                </a:gridCol>
                <a:gridCol w="1119673">
                  <a:extLst>
                    <a:ext uri="{9D8B030D-6E8A-4147-A177-3AD203B41FA5}">
                      <a16:colId xmlns:a16="http://schemas.microsoft.com/office/drawing/2014/main" val="4176867927"/>
                    </a:ext>
                  </a:extLst>
                </a:gridCol>
                <a:gridCol w="1147666">
                  <a:extLst>
                    <a:ext uri="{9D8B030D-6E8A-4147-A177-3AD203B41FA5}">
                      <a16:colId xmlns:a16="http://schemas.microsoft.com/office/drawing/2014/main" val="3503899384"/>
                    </a:ext>
                  </a:extLst>
                </a:gridCol>
                <a:gridCol w="1175657">
                  <a:extLst>
                    <a:ext uri="{9D8B030D-6E8A-4147-A177-3AD203B41FA5}">
                      <a16:colId xmlns:a16="http://schemas.microsoft.com/office/drawing/2014/main" val="4240591376"/>
                    </a:ext>
                  </a:extLst>
                </a:gridCol>
                <a:gridCol w="1138335">
                  <a:extLst>
                    <a:ext uri="{9D8B030D-6E8A-4147-A177-3AD203B41FA5}">
                      <a16:colId xmlns:a16="http://schemas.microsoft.com/office/drawing/2014/main" val="3794859709"/>
                    </a:ext>
                  </a:extLst>
                </a:gridCol>
                <a:gridCol w="1222310">
                  <a:extLst>
                    <a:ext uri="{9D8B030D-6E8A-4147-A177-3AD203B41FA5}">
                      <a16:colId xmlns:a16="http://schemas.microsoft.com/office/drawing/2014/main" val="199999090"/>
                    </a:ext>
                  </a:extLst>
                </a:gridCol>
                <a:gridCol w="1220268">
                  <a:extLst>
                    <a:ext uri="{9D8B030D-6E8A-4147-A177-3AD203B41FA5}">
                      <a16:colId xmlns:a16="http://schemas.microsoft.com/office/drawing/2014/main" val="2365433027"/>
                    </a:ext>
                  </a:extLst>
                </a:gridCol>
              </a:tblGrid>
              <a:tr h="0"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S.No</a:t>
                      </a:r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Analyte Autoantibody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Status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0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4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S (N=10)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≥ 2-fold in abs median value (% positive)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4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S (N=8)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≥ 2-fold in abs median value (% positive)</a:t>
                      </a:r>
                      <a:endParaRPr lang="en-US" sz="10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9487665"/>
                  </a:ext>
                </a:extLst>
              </a:tr>
              <a:tr h="267804">
                <a:tc vMerge="1">
                  <a:txBody>
                    <a:bodyPr/>
                    <a:lstStyle/>
                    <a:p>
                      <a:pPr algn="ctr"/>
                      <a:endParaRPr 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US" sz="1100" b="1" i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i="1" dirty="0" err="1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PrC</a:t>
                      </a:r>
                      <a:r>
                        <a:rPr lang="en-US" sz="1000" b="1" i="1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 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i="1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PoC1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i="1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PoC2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i="1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PoC3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i="1" dirty="0" err="1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PrC</a:t>
                      </a:r>
                      <a:endParaRPr lang="en-US" sz="1000" b="1" i="1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i="1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PoC1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i="1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PoC2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i="1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PoC3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7299733"/>
                  </a:ext>
                </a:extLst>
              </a:tr>
              <a:tr h="493967"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IFN-2 alpha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Alive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672 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4.173 (40%)</a:t>
                      </a:r>
                      <a:endParaRPr lang="en-US" sz="100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8.403 (10%)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8.063 (10%)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.937 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4.368 (12.5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07772838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Deceased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  <a:endParaRPr lang="en-US" sz="100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.99 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4.368 (25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7.809 (25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8.408 (12.5%)</a:t>
                      </a:r>
                      <a:endParaRPr lang="en-US" sz="100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01906095"/>
                  </a:ext>
                </a:extLst>
              </a:tr>
              <a:tr h="342900"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IFN Lambda-1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Alive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.642 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5.959 (10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6.443 (10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5.344 (10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9573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4.086 (12.5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.9287 (12.5%)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4.8709 (12.5%)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34306828"/>
                  </a:ext>
                </a:extLst>
              </a:tr>
              <a:tr h="40951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Deceased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  <a:endParaRPr lang="en-US" sz="100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158 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3.998 (37.5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.850 (37.5%)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3.150 (12.5%)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69618490"/>
                  </a:ext>
                </a:extLst>
              </a:tr>
              <a:tr h="303341"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IFN Lambda-3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Alive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3.09 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7.021 (30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9.628 (10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8.126 (10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019 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6.6593 (12.5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6.7293 (12.5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7.0809 (12.5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81966597"/>
                  </a:ext>
                </a:extLst>
              </a:tr>
              <a:tr h="34725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Deceased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  <a:endParaRPr lang="en-US" sz="100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017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5.9142 (12.5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7.1762 (12.5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7.859 (12.5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23957655"/>
                  </a:ext>
                </a:extLst>
              </a:tr>
              <a:tr h="224470"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IFN epsilon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Alive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01 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4.752 (10%)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50417635"/>
                  </a:ext>
                </a:extLst>
              </a:tr>
              <a:tr h="34529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Deceased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  <a:endParaRPr lang="en-US" sz="100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02 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3.987 (12.5%)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7.258 (12.5%)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7.917 (12.5%)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76660526"/>
                  </a:ext>
                </a:extLst>
              </a:tr>
            </a:tbl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33C13756-8856-4326-8166-BDB070FB2A1F}"/>
              </a:ext>
            </a:extLst>
          </p:cNvPr>
          <p:cNvSpPr txBox="1"/>
          <p:nvPr/>
        </p:nvSpPr>
        <p:spPr>
          <a:xfrm>
            <a:off x="1847273" y="91324"/>
            <a:ext cx="848663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Table A1: Changes in interferon-related IgG autoantibodies in LT recipients before and after SARS-CoV-2 infection over time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5B582DB-D4F5-4F1A-B906-995A0B3AE1A2}"/>
              </a:ext>
            </a:extLst>
          </p:cNvPr>
          <p:cNvSpPr txBox="1"/>
          <p:nvPr/>
        </p:nvSpPr>
        <p:spPr>
          <a:xfrm>
            <a:off x="110412" y="4248005"/>
            <a:ext cx="11864252" cy="3077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just" defTabSz="91440"/>
            <a:r>
              <a:rPr lang="en-US" sz="10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NS</a:t>
            </a:r>
            <a:r>
              <a:rPr lang="en-US" sz="1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, non-severe COVID-19 (mild to moderate)  (total N=10); </a:t>
            </a:r>
            <a:r>
              <a:rPr lang="en-US" sz="10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S</a:t>
            </a:r>
            <a:r>
              <a:rPr lang="en-US" sz="1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, severe COVID-19 (severe to critical) (total N=8);  </a:t>
            </a:r>
            <a:r>
              <a:rPr lang="en-US" sz="1000" baseline="30000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PrC</a:t>
            </a:r>
            <a:r>
              <a:rPr lang="en-US" sz="1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	, Pre-COVID-19; </a:t>
            </a:r>
            <a:r>
              <a:rPr lang="en-US" sz="10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PoC1</a:t>
            </a:r>
            <a:r>
              <a:rPr lang="en-US" sz="1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, Post-COVID-19 sample 1; </a:t>
            </a:r>
            <a:r>
              <a:rPr lang="en-US" sz="10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PoC2</a:t>
            </a:r>
            <a:r>
              <a:rPr lang="en-US" sz="1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, Post-COVID-19 sample 2; </a:t>
            </a:r>
            <a:r>
              <a:rPr lang="en-US" sz="10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PoC3</a:t>
            </a:r>
            <a:r>
              <a:rPr lang="en-US" sz="1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, Post-COVID-19 sample 3;  </a:t>
            </a:r>
            <a:r>
              <a:rPr lang="en-US" sz="10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None</a:t>
            </a:r>
            <a:r>
              <a:rPr lang="en-US" sz="1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, No death observed; </a:t>
            </a:r>
            <a:r>
              <a:rPr lang="en-US" sz="10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NA </a:t>
            </a:r>
            <a:r>
              <a:rPr lang="en-US" sz="1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, not applicable; </a:t>
            </a:r>
            <a:r>
              <a:rPr lang="en-US" sz="1000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ie</a:t>
            </a:r>
            <a:r>
              <a:rPr lang="en-US" sz="1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. no expression found with the applied criteria of ≥ 2-fold in abs value. </a:t>
            </a:r>
          </a:p>
        </p:txBody>
      </p:sp>
    </p:spTree>
    <p:extLst>
      <p:ext uri="{BB962C8B-B14F-4D97-AF65-F5344CB8AC3E}">
        <p14:creationId xmlns:p14="http://schemas.microsoft.com/office/powerpoint/2010/main" val="41681100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4">
            <a:extLst>
              <a:ext uri="{FF2B5EF4-FFF2-40B4-BE49-F238E27FC236}">
                <a16:creationId xmlns:a16="http://schemas.microsoft.com/office/drawing/2014/main" id="{E08649A9-F922-4274-9FB9-9E262C6BCE5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05515302"/>
              </p:ext>
            </p:extLst>
          </p:nvPr>
        </p:nvGraphicFramePr>
        <p:xfrm>
          <a:off x="110412" y="326637"/>
          <a:ext cx="11971176" cy="559706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544869">
                  <a:extLst>
                    <a:ext uri="{9D8B030D-6E8A-4147-A177-3AD203B41FA5}">
                      <a16:colId xmlns:a16="http://schemas.microsoft.com/office/drawing/2014/main" val="2663020636"/>
                    </a:ext>
                  </a:extLst>
                </a:gridCol>
                <a:gridCol w="1115913">
                  <a:extLst>
                    <a:ext uri="{9D8B030D-6E8A-4147-A177-3AD203B41FA5}">
                      <a16:colId xmlns:a16="http://schemas.microsoft.com/office/drawing/2014/main" val="3312365198"/>
                    </a:ext>
                  </a:extLst>
                </a:gridCol>
                <a:gridCol w="830491">
                  <a:extLst>
                    <a:ext uri="{9D8B030D-6E8A-4147-A177-3AD203B41FA5}">
                      <a16:colId xmlns:a16="http://schemas.microsoft.com/office/drawing/2014/main" val="2112926917"/>
                    </a:ext>
                  </a:extLst>
                </a:gridCol>
                <a:gridCol w="1329030">
                  <a:extLst>
                    <a:ext uri="{9D8B030D-6E8A-4147-A177-3AD203B41FA5}">
                      <a16:colId xmlns:a16="http://schemas.microsoft.com/office/drawing/2014/main" val="1275774156"/>
                    </a:ext>
                  </a:extLst>
                </a:gridCol>
                <a:gridCol w="1126964">
                  <a:extLst>
                    <a:ext uri="{9D8B030D-6E8A-4147-A177-3AD203B41FA5}">
                      <a16:colId xmlns:a16="http://schemas.microsoft.com/office/drawing/2014/main" val="1471504787"/>
                    </a:ext>
                  </a:extLst>
                </a:gridCol>
                <a:gridCol w="1119673">
                  <a:extLst>
                    <a:ext uri="{9D8B030D-6E8A-4147-A177-3AD203B41FA5}">
                      <a16:colId xmlns:a16="http://schemas.microsoft.com/office/drawing/2014/main" val="4176867927"/>
                    </a:ext>
                  </a:extLst>
                </a:gridCol>
                <a:gridCol w="1147666">
                  <a:extLst>
                    <a:ext uri="{9D8B030D-6E8A-4147-A177-3AD203B41FA5}">
                      <a16:colId xmlns:a16="http://schemas.microsoft.com/office/drawing/2014/main" val="3503899384"/>
                    </a:ext>
                  </a:extLst>
                </a:gridCol>
                <a:gridCol w="1175657">
                  <a:extLst>
                    <a:ext uri="{9D8B030D-6E8A-4147-A177-3AD203B41FA5}">
                      <a16:colId xmlns:a16="http://schemas.microsoft.com/office/drawing/2014/main" val="4240591376"/>
                    </a:ext>
                  </a:extLst>
                </a:gridCol>
                <a:gridCol w="1138335">
                  <a:extLst>
                    <a:ext uri="{9D8B030D-6E8A-4147-A177-3AD203B41FA5}">
                      <a16:colId xmlns:a16="http://schemas.microsoft.com/office/drawing/2014/main" val="3794859709"/>
                    </a:ext>
                  </a:extLst>
                </a:gridCol>
                <a:gridCol w="1222310">
                  <a:extLst>
                    <a:ext uri="{9D8B030D-6E8A-4147-A177-3AD203B41FA5}">
                      <a16:colId xmlns:a16="http://schemas.microsoft.com/office/drawing/2014/main" val="199999090"/>
                    </a:ext>
                  </a:extLst>
                </a:gridCol>
                <a:gridCol w="1220268">
                  <a:extLst>
                    <a:ext uri="{9D8B030D-6E8A-4147-A177-3AD203B41FA5}">
                      <a16:colId xmlns:a16="http://schemas.microsoft.com/office/drawing/2014/main" val="2365433027"/>
                    </a:ext>
                  </a:extLst>
                </a:gridCol>
              </a:tblGrid>
              <a:tr h="0"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S.No</a:t>
                      </a:r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Analyte Autoantibody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Status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0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4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S (N=10)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≥ 2-fold in abs median value (% positive)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4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S (N=8)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≥ 2-fold in abs median value (% positive)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9487665"/>
                  </a:ext>
                </a:extLst>
              </a:tr>
              <a:tr h="267804">
                <a:tc vMerge="1">
                  <a:txBody>
                    <a:bodyPr/>
                    <a:lstStyle/>
                    <a:p>
                      <a:pPr algn="ctr"/>
                      <a:endParaRPr 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US" sz="1100" b="1" i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i="1" dirty="0" err="1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PrC</a:t>
                      </a:r>
                      <a:r>
                        <a:rPr lang="en-US" sz="1000" b="1" i="1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 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i="1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PoC1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i="1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PoC2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i="1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PoC3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i="1" dirty="0" err="1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PrC</a:t>
                      </a:r>
                      <a:endParaRPr lang="en-US" sz="1000" b="1" i="1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i="1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PoC1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i="1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PoC2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i="1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PoC3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7299733"/>
                  </a:ext>
                </a:extLst>
              </a:tr>
              <a:tr h="322477"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IL-2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Alive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002 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4.57 (60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5.21 (20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3.740 (10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 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6.292 (25%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.172 (25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4.312 (25%)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07772838"/>
                  </a:ext>
                </a:extLst>
              </a:tr>
              <a:tr h="31132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Deceased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  <a:endParaRPr lang="en-US" sz="100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004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.446 (37.5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6.324 (37.5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0.160 (12.5%)</a:t>
                      </a:r>
                      <a:endParaRPr lang="en-US" sz="100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01906095"/>
                  </a:ext>
                </a:extLst>
              </a:tr>
              <a:tr h="0"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IL-6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Alive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 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002 (10%)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011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4.7691 (12.5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4.7161 (12.5%)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5.8521 (12.5%)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34306828"/>
                  </a:ext>
                </a:extLst>
              </a:tr>
              <a:tr h="38477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Deceased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  <a:endParaRPr lang="en-US" sz="100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.112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4.986 (25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5.096 (25%)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7.299 (12.5%)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69618490"/>
                  </a:ext>
                </a:extLst>
              </a:tr>
              <a:tr h="311084"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IL-8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Alive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81966597"/>
                  </a:ext>
                </a:extLst>
              </a:tr>
              <a:tr h="37707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Deceased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  <a:endParaRPr lang="en-US" sz="100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3.560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5.059 (12.5%)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8.357 (12.5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8.453 (12.5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23957655"/>
                  </a:ext>
                </a:extLst>
              </a:tr>
              <a:tr h="337636"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IL-10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Alive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735 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4.211 (30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7.836 (10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6.259 (10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011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8.228 (25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3.069 (12.5%)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4.883 (12.5%)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50417635"/>
                  </a:ext>
                </a:extLst>
              </a:tr>
              <a:tr h="35952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Deceased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  <a:endParaRPr lang="en-US" sz="100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008 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015 (12.5%)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6.316 (12.5%)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6.928 (12.5%)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76660526"/>
                  </a:ext>
                </a:extLst>
              </a:tr>
              <a:tr h="359524"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IL-15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Alive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06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4.15 (30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8.081 (10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8.755 (10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011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5.6716 (12.5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6.830 (12.5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7.704 (12.5%)</a:t>
                      </a:r>
                      <a:endParaRPr lang="en-US" sz="100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10013518"/>
                  </a:ext>
                </a:extLst>
              </a:tr>
              <a:tr h="35952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Deceased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  <a:endParaRPr lang="en-US" sz="100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006 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.4063 (12.5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7.5176 (12.5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8.3771 (12.5%)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50919974"/>
                  </a:ext>
                </a:extLst>
              </a:tr>
              <a:tr h="359524"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IL-17A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Alive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17737153"/>
                  </a:ext>
                </a:extLst>
              </a:tr>
              <a:tr h="35952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Deceased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  <a:endParaRPr lang="en-US" sz="100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3.578 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6.766 (12.5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7.55 (12.5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8.409 (12.5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49745493"/>
                  </a:ext>
                </a:extLst>
              </a:tr>
              <a:tr h="0"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7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IL-22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Alive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.822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.881 (20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8.186 (10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6.155 (10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008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004 (12.5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6.140 (12.5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5.613 (12.5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03690235"/>
                  </a:ext>
                </a:extLst>
              </a:tr>
              <a:tr h="35952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Deceased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  <a:endParaRPr lang="en-US" sz="100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981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3.172 (25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6.195 (25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7.408 (12.5%)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45021576"/>
                  </a:ext>
                </a:extLst>
              </a:tr>
            </a:tbl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33C13756-8856-4326-8166-BDB070FB2A1F}"/>
              </a:ext>
            </a:extLst>
          </p:cNvPr>
          <p:cNvSpPr txBox="1"/>
          <p:nvPr/>
        </p:nvSpPr>
        <p:spPr>
          <a:xfrm>
            <a:off x="1563732" y="17892"/>
            <a:ext cx="86643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Table A2: Changes in interleukin-related IgG autoantibodies in LT recipients prior to and after SARS-CoV-2 infection over time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0B05801E-3DAF-3254-0642-0C3204EC92F6}"/>
              </a:ext>
            </a:extLst>
          </p:cNvPr>
          <p:cNvSpPr txBox="1"/>
          <p:nvPr/>
        </p:nvSpPr>
        <p:spPr>
          <a:xfrm>
            <a:off x="110412" y="5987312"/>
            <a:ext cx="11864252" cy="3077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just" defTabSz="91440"/>
            <a:r>
              <a:rPr lang="en-US" sz="10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NS</a:t>
            </a:r>
            <a:r>
              <a:rPr lang="en-US" sz="1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, non-severe COVID-19 (mild to moderate)  (total N=10); </a:t>
            </a:r>
            <a:r>
              <a:rPr lang="en-US" sz="10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S</a:t>
            </a:r>
            <a:r>
              <a:rPr lang="en-US" sz="1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, severe COVID-19 (severe to critical) (total N=8);  </a:t>
            </a:r>
            <a:r>
              <a:rPr lang="en-US" sz="1000" baseline="30000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PrC</a:t>
            </a:r>
            <a:r>
              <a:rPr lang="en-US" sz="1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	, Pre-COVID-19; </a:t>
            </a:r>
            <a:r>
              <a:rPr lang="en-US" sz="10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PoC1</a:t>
            </a:r>
            <a:r>
              <a:rPr lang="en-US" sz="1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, Post-COVID-19 sample 1; </a:t>
            </a:r>
            <a:r>
              <a:rPr lang="en-US" sz="10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PoC2</a:t>
            </a:r>
            <a:r>
              <a:rPr lang="en-US" sz="1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, Post-COVID-19 sample 2; </a:t>
            </a:r>
            <a:r>
              <a:rPr lang="en-US" sz="10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PoC3</a:t>
            </a:r>
            <a:r>
              <a:rPr lang="en-US" sz="1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, Post-COVID-19 sample 3;  </a:t>
            </a:r>
            <a:r>
              <a:rPr lang="en-US" sz="10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None</a:t>
            </a:r>
            <a:r>
              <a:rPr lang="en-US" sz="1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, No death observed; </a:t>
            </a:r>
            <a:r>
              <a:rPr lang="en-US" sz="10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NA </a:t>
            </a:r>
            <a:r>
              <a:rPr lang="en-US" sz="1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, not applicable; </a:t>
            </a:r>
            <a:r>
              <a:rPr lang="en-US" sz="1000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ie</a:t>
            </a:r>
            <a:r>
              <a:rPr lang="en-US" sz="1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. no expression found with the applied criteria of ≥ 2-fold in abs value. </a:t>
            </a:r>
          </a:p>
        </p:txBody>
      </p:sp>
    </p:spTree>
    <p:extLst>
      <p:ext uri="{BB962C8B-B14F-4D97-AF65-F5344CB8AC3E}">
        <p14:creationId xmlns:p14="http://schemas.microsoft.com/office/powerpoint/2010/main" val="28184940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4">
            <a:extLst>
              <a:ext uri="{FF2B5EF4-FFF2-40B4-BE49-F238E27FC236}">
                <a16:creationId xmlns:a16="http://schemas.microsoft.com/office/drawing/2014/main" id="{E08649A9-F922-4274-9FB9-9E262C6BCE5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06968695"/>
              </p:ext>
            </p:extLst>
          </p:nvPr>
        </p:nvGraphicFramePr>
        <p:xfrm>
          <a:off x="387512" y="487448"/>
          <a:ext cx="11416975" cy="502105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547870">
                  <a:extLst>
                    <a:ext uri="{9D8B030D-6E8A-4147-A177-3AD203B41FA5}">
                      <a16:colId xmlns:a16="http://schemas.microsoft.com/office/drawing/2014/main" val="2663020636"/>
                    </a:ext>
                  </a:extLst>
                </a:gridCol>
                <a:gridCol w="1150070">
                  <a:extLst>
                    <a:ext uri="{9D8B030D-6E8A-4147-A177-3AD203B41FA5}">
                      <a16:colId xmlns:a16="http://schemas.microsoft.com/office/drawing/2014/main" val="3312365198"/>
                    </a:ext>
                  </a:extLst>
                </a:gridCol>
                <a:gridCol w="895547">
                  <a:extLst>
                    <a:ext uri="{9D8B030D-6E8A-4147-A177-3AD203B41FA5}">
                      <a16:colId xmlns:a16="http://schemas.microsoft.com/office/drawing/2014/main" val="2112926917"/>
                    </a:ext>
                  </a:extLst>
                </a:gridCol>
                <a:gridCol w="989814">
                  <a:extLst>
                    <a:ext uri="{9D8B030D-6E8A-4147-A177-3AD203B41FA5}">
                      <a16:colId xmlns:a16="http://schemas.microsoft.com/office/drawing/2014/main" val="1275774156"/>
                    </a:ext>
                  </a:extLst>
                </a:gridCol>
                <a:gridCol w="1084083">
                  <a:extLst>
                    <a:ext uri="{9D8B030D-6E8A-4147-A177-3AD203B41FA5}">
                      <a16:colId xmlns:a16="http://schemas.microsoft.com/office/drawing/2014/main" val="1471504787"/>
                    </a:ext>
                  </a:extLst>
                </a:gridCol>
                <a:gridCol w="1027521">
                  <a:extLst>
                    <a:ext uri="{9D8B030D-6E8A-4147-A177-3AD203B41FA5}">
                      <a16:colId xmlns:a16="http://schemas.microsoft.com/office/drawing/2014/main" val="2982536455"/>
                    </a:ext>
                  </a:extLst>
                </a:gridCol>
                <a:gridCol w="933254">
                  <a:extLst>
                    <a:ext uri="{9D8B030D-6E8A-4147-A177-3AD203B41FA5}">
                      <a16:colId xmlns:a16="http://schemas.microsoft.com/office/drawing/2014/main" val="3420406299"/>
                    </a:ext>
                  </a:extLst>
                </a:gridCol>
                <a:gridCol w="1244338">
                  <a:extLst>
                    <a:ext uri="{9D8B030D-6E8A-4147-A177-3AD203B41FA5}">
                      <a16:colId xmlns:a16="http://schemas.microsoft.com/office/drawing/2014/main" val="4240591376"/>
                    </a:ext>
                  </a:extLst>
                </a:gridCol>
                <a:gridCol w="1234911">
                  <a:extLst>
                    <a:ext uri="{9D8B030D-6E8A-4147-A177-3AD203B41FA5}">
                      <a16:colId xmlns:a16="http://schemas.microsoft.com/office/drawing/2014/main" val="3794859709"/>
                    </a:ext>
                  </a:extLst>
                </a:gridCol>
                <a:gridCol w="1168924">
                  <a:extLst>
                    <a:ext uri="{9D8B030D-6E8A-4147-A177-3AD203B41FA5}">
                      <a16:colId xmlns:a16="http://schemas.microsoft.com/office/drawing/2014/main" val="343105189"/>
                    </a:ext>
                  </a:extLst>
                </a:gridCol>
                <a:gridCol w="1140643">
                  <a:extLst>
                    <a:ext uri="{9D8B030D-6E8A-4147-A177-3AD203B41FA5}">
                      <a16:colId xmlns:a16="http://schemas.microsoft.com/office/drawing/2014/main" val="1402211848"/>
                    </a:ext>
                  </a:extLst>
                </a:gridCol>
              </a:tblGrid>
              <a:tr h="0"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S.No</a:t>
                      </a:r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Analyte Autoantibody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Status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0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4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S (N=10)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≥ 2-fold in abs median value (% positive)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4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S (N=8)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≥ 2-fold in abs median value (% positive)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9487665"/>
                  </a:ext>
                </a:extLst>
              </a:tr>
              <a:tr h="267804">
                <a:tc vMerge="1">
                  <a:txBody>
                    <a:bodyPr/>
                    <a:lstStyle/>
                    <a:p>
                      <a:pPr algn="ctr"/>
                      <a:endParaRPr 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US" sz="1100" b="1" i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i="1" dirty="0" err="1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PrC</a:t>
                      </a:r>
                      <a:r>
                        <a:rPr lang="en-US" sz="1000" b="1" i="1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 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i="1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PoC1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i="1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PoC2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i="1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PoC3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i="1" dirty="0" err="1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PrC</a:t>
                      </a:r>
                      <a:endParaRPr lang="en-US" sz="1000" b="1" i="1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i="1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PoC1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i="1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PoC2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i="1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PoC3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7299733"/>
                  </a:ext>
                </a:extLst>
              </a:tr>
              <a:tr h="501038"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dsDNA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Alive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002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4.57 (60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07772838"/>
                  </a:ext>
                </a:extLst>
              </a:tr>
              <a:tr h="39949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Deceased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  <a:endParaRPr lang="en-US" sz="100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012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6.8219 (12.5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8.0753 (12.5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01906095"/>
                  </a:ext>
                </a:extLst>
              </a:tr>
              <a:tr h="274196"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Gp-210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Alive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3.9266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8.3500 (10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3.815 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8.203 (12.5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34306828"/>
                  </a:ext>
                </a:extLst>
              </a:tr>
              <a:tr h="36583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Deceased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  <a:endParaRPr lang="en-US" sz="100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3.336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7.229 (25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7.079 (25%)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69618490"/>
                  </a:ext>
                </a:extLst>
              </a:tr>
              <a:tr h="301723"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Vimentin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Alive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008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5.422 (12.5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303 (12.5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5.365 (12.5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81966597"/>
                  </a:ext>
                </a:extLst>
              </a:tr>
              <a:tr h="36598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Deceased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  <a:endParaRPr lang="en-US" sz="100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.732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3.701 (25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.354 (25%)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6.277 (12.5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23957655"/>
                  </a:ext>
                </a:extLst>
              </a:tr>
              <a:tr h="311085"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Laminin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Alive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003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4.268 (10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.551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5.689 (12.5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6.732 (12.5%)</a:t>
                      </a:r>
                    </a:p>
                  </a:txBody>
                  <a:tcPr marL="7620" marR="7620" marT="91440" marB="9144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6.732 (12.5%)</a:t>
                      </a:r>
                    </a:p>
                  </a:txBody>
                  <a:tcPr marT="91440" marB="9144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45450918"/>
                  </a:ext>
                </a:extLst>
              </a:tr>
              <a:tr h="36591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Deceased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  <a:endParaRPr lang="en-US" sz="100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013 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.9006 (12.5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7.472 (12.5%)</a:t>
                      </a:r>
                    </a:p>
                  </a:txBody>
                  <a:tcPr marL="7620" marR="7620" marT="91440" marB="9144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7.955 (12.5%)</a:t>
                      </a:r>
                    </a:p>
                  </a:txBody>
                  <a:tcPr marT="91440" marB="9144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21628715"/>
                  </a:ext>
                </a:extLst>
              </a:tr>
              <a:tr h="329938"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TNF beta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Alive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001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5.1841 (10%)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55170280"/>
                  </a:ext>
                </a:extLst>
              </a:tr>
              <a:tr h="3470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Deceased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  <a:endParaRPr lang="en-US" sz="100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.172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017 (12.5%)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7.512 (12.5%)</a:t>
                      </a:r>
                    </a:p>
                  </a:txBody>
                  <a:tcPr marT="91440" marB="9144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7.986 (12.5%)</a:t>
                      </a:r>
                    </a:p>
                  </a:txBody>
                  <a:tcPr marT="91440" marB="9144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1591713"/>
                  </a:ext>
                </a:extLst>
              </a:tr>
              <a:tr h="307628"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LKM-1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Alive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3.155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7.312 (10%)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65709061"/>
                  </a:ext>
                </a:extLst>
              </a:tr>
              <a:tr h="30589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Deceased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  <a:endParaRPr lang="en-US" sz="100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7620" marR="7620" marT="91440" marB="914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67435885"/>
                  </a:ext>
                </a:extLst>
              </a:tr>
            </a:tbl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33C13756-8856-4326-8166-BDB070FB2A1F}"/>
              </a:ext>
            </a:extLst>
          </p:cNvPr>
          <p:cNvSpPr txBox="1"/>
          <p:nvPr/>
        </p:nvSpPr>
        <p:spPr>
          <a:xfrm>
            <a:off x="2060770" y="115413"/>
            <a:ext cx="84406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Table A3: Changes in other IgG autoantibodies in LT recipients between pre- and post- SARS-CoV-2 infection over time 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BF178A3E-9FBF-1238-B5A5-27E88B3C313D}"/>
              </a:ext>
            </a:extLst>
          </p:cNvPr>
          <p:cNvSpPr txBox="1"/>
          <p:nvPr/>
        </p:nvSpPr>
        <p:spPr>
          <a:xfrm>
            <a:off x="387512" y="5634316"/>
            <a:ext cx="11416975" cy="3077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just" defTabSz="91440"/>
            <a:r>
              <a:rPr lang="en-US" sz="10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NS</a:t>
            </a:r>
            <a:r>
              <a:rPr lang="en-US" sz="1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, non-severe COVID-19 (mild to moderate)  (total N=10); </a:t>
            </a:r>
            <a:r>
              <a:rPr lang="en-US" sz="10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S</a:t>
            </a:r>
            <a:r>
              <a:rPr lang="en-US" sz="1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, severe COVID-19 (severe to critical) (total N=8);  </a:t>
            </a:r>
            <a:r>
              <a:rPr lang="en-US" sz="1000" baseline="30000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PrC</a:t>
            </a:r>
            <a:r>
              <a:rPr lang="en-US" sz="1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	, Pre-COVID-19; </a:t>
            </a:r>
            <a:r>
              <a:rPr lang="en-US" sz="10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PoC1</a:t>
            </a:r>
            <a:r>
              <a:rPr lang="en-US" sz="1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, Post-COVID-19 sample 1; </a:t>
            </a:r>
            <a:r>
              <a:rPr lang="en-US" sz="10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PoC2</a:t>
            </a:r>
            <a:r>
              <a:rPr lang="en-US" sz="1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, Post-COVID-19 sample 2; </a:t>
            </a:r>
            <a:r>
              <a:rPr lang="en-US" sz="10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PoC3</a:t>
            </a:r>
            <a:r>
              <a:rPr lang="en-US" sz="1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, Post-COVID-19 sample 3;  </a:t>
            </a:r>
            <a:r>
              <a:rPr lang="en-US" sz="10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None</a:t>
            </a:r>
            <a:r>
              <a:rPr lang="en-US" sz="1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, No death observed; </a:t>
            </a:r>
            <a:r>
              <a:rPr lang="en-US" sz="10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NA </a:t>
            </a:r>
            <a:r>
              <a:rPr lang="en-US" sz="1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, not applicable; </a:t>
            </a:r>
            <a:r>
              <a:rPr lang="en-US" sz="1000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ie</a:t>
            </a:r>
            <a:r>
              <a:rPr lang="en-US" sz="1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. no expression found with the applied criteria of ≥ 2-fold in abs value. </a:t>
            </a:r>
          </a:p>
        </p:txBody>
      </p:sp>
    </p:spTree>
    <p:extLst>
      <p:ext uri="{BB962C8B-B14F-4D97-AF65-F5344CB8AC3E}">
        <p14:creationId xmlns:p14="http://schemas.microsoft.com/office/powerpoint/2010/main" val="292815027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719AD24B-8832-4C51-AD7F-D012379771C9}"/>
              </a:ext>
            </a:extLst>
          </p:cNvPr>
          <p:cNvSpPr txBox="1"/>
          <p:nvPr/>
        </p:nvSpPr>
        <p:spPr>
          <a:xfrm>
            <a:off x="550416" y="18033"/>
            <a:ext cx="12192000" cy="153888"/>
          </a:xfrm>
          <a:prstGeom prst="rect">
            <a:avLst/>
          </a:prstGeom>
          <a:noFill/>
        </p:spPr>
        <p:txBody>
          <a:bodyPr wrap="square" lIns="0" tIns="0" rIns="0" bIns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0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able A4a: Univariate linear regression model-based significantly altered AAbs in association with disease severity, or DSA, or time since transplant in COVID-19 LTRs</a:t>
            </a:r>
            <a:endParaRPr lang="en-US" sz="1000" b="1" dirty="0">
              <a:effectLst/>
              <a:latin typeface="Palatino Linotype" panose="0204050205050503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222A6EDF-6200-15A6-DAD8-032BF096D1D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75309780"/>
              </p:ext>
            </p:extLst>
          </p:nvPr>
        </p:nvGraphicFramePr>
        <p:xfrm>
          <a:off x="973092" y="311669"/>
          <a:ext cx="9751134" cy="602950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666556">
                  <a:extLst>
                    <a:ext uri="{9D8B030D-6E8A-4147-A177-3AD203B41FA5}">
                      <a16:colId xmlns:a16="http://schemas.microsoft.com/office/drawing/2014/main" val="2360358312"/>
                    </a:ext>
                  </a:extLst>
                </a:gridCol>
                <a:gridCol w="2484960">
                  <a:extLst>
                    <a:ext uri="{9D8B030D-6E8A-4147-A177-3AD203B41FA5}">
                      <a16:colId xmlns:a16="http://schemas.microsoft.com/office/drawing/2014/main" val="123949840"/>
                    </a:ext>
                  </a:extLst>
                </a:gridCol>
                <a:gridCol w="1799295">
                  <a:extLst>
                    <a:ext uri="{9D8B030D-6E8A-4147-A177-3AD203B41FA5}">
                      <a16:colId xmlns:a16="http://schemas.microsoft.com/office/drawing/2014/main" val="260315434"/>
                    </a:ext>
                  </a:extLst>
                </a:gridCol>
                <a:gridCol w="1483096">
                  <a:extLst>
                    <a:ext uri="{9D8B030D-6E8A-4147-A177-3AD203B41FA5}">
                      <a16:colId xmlns:a16="http://schemas.microsoft.com/office/drawing/2014/main" val="1231783432"/>
                    </a:ext>
                  </a:extLst>
                </a:gridCol>
                <a:gridCol w="677432">
                  <a:extLst>
                    <a:ext uri="{9D8B030D-6E8A-4147-A177-3AD203B41FA5}">
                      <a16:colId xmlns:a16="http://schemas.microsoft.com/office/drawing/2014/main" val="1858569581"/>
                    </a:ext>
                  </a:extLst>
                </a:gridCol>
                <a:gridCol w="639795">
                  <a:extLst>
                    <a:ext uri="{9D8B030D-6E8A-4147-A177-3AD203B41FA5}">
                      <a16:colId xmlns:a16="http://schemas.microsoft.com/office/drawing/2014/main" val="2841749830"/>
                    </a:ext>
                  </a:extLst>
                </a:gridCol>
              </a:tblGrid>
              <a:tr h="198429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Antibody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Variable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Estimate ± SE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96% CI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 err="1"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PValue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R</a:t>
                      </a:r>
                      <a:r>
                        <a:rPr lang="en-US" sz="1000" b="1" u="none" strike="noStrike" baseline="30000" dirty="0"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sz="1000" b="1" i="0" u="none" strike="noStrike" baseline="30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2088624"/>
                  </a:ext>
                </a:extLst>
              </a:tr>
              <a:tr h="66657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BCOADC-E2/OGDC-E2/PDC-E2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Intercept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-0.7947±0.3270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-1.4961,-0.0934)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291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4709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76894998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COVID-19 Severity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7112±0.2959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0.0766,1.3458)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307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04931330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Time Post Transplant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004±0.0001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0.0001,0.0006)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173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1838239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History of DSA Prior to COVID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-0.0490±0.2956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-0.6830,0.5851)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8708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05876077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Collagen V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Intercept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-1.2640±0.3946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-2.1103,-0.4176)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064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4034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96808335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COVID-19 Severity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8743±0.3571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0.1085,1.6401)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281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05872753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Time Post Transplant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001±0.0002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-0.0002,0.0005)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4296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4053606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History of DSA Prior to COVID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7489±0.3567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-0.0162,1.5139)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544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1215616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GM-CSF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Intercept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6535±0.5604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-0.5484,1.8555)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2630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4474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2200292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COVID Severe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-0.6200±0.5071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-1.7076,0.4675)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2416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79152096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Time Post Transplant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006±0.0002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0.0002,0.0011)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130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61982354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History of DSA Prior to COVID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-0.5091±0.5066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-1.5956,0.5775)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3320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24897475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IFN-lambda 1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Intercept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-1.2122±0.8799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-3.0995,0.6751)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1900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3763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15948965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COVID Severe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.0666±0.7962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0.3589,3.7742)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212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7086328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Time Post Transplant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003±0.0004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-0.0005,0.0010)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4931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98040019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History of DSA Prior to COVID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.2483±0.7954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-0.4577,2.9544)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1389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89113289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IL-1 alpha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Intercept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-0.7844±0.3535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-1.5426,-0.0261)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436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4468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7496255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COVID Severe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2510±0.3199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-0.4351,0.9371)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4457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3032380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Time Post Transplant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005±0.0001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0.0002,0.0008)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052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0515959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History of DSA Prior to COVID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2175±0.3196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-0.4680,0.9029)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5073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6140875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IL-12 (p70)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Intercept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-0.6260±0.3998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-1.4835,0.2314)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1397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4240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19259297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COVID Severe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4502±0.3617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-0.3256,1.2260)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2337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77143087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Time Post Transplant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005±0.0002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0.0001,0.0008)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093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40644545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History of DSA Prior to COVID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2926±0.3614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-0.4825,1.0678)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4316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31901007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IL-22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Intercept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-0.9360±0.7016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-2.4407,0.5687)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2035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5550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2277126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COVID Severe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.5713±0.6348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1.2098,3.9328)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012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08998420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Time Post Transplant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003±0.0003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-0.0003,0.0009)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3656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57461214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History of DSA Prior to COVID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8818±0.6342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-0.4784,2.2420)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1861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8493276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u="none" strike="noStrike" dirty="0"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Jo-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Intercept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-0.1654±0.3433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-0.9016,0.5709)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6374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4021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11519800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1" u="none" strike="noStrike" dirty="0"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COVID Severe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-0.2506±0.3106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-0.9167,0.4156)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4333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65513104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1" u="none" strike="noStrike" dirty="0"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Time Post Transplant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004±0.0001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0.0001,0.0007)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231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08454197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1" u="none" strike="noStrike" dirty="0"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History of DSA Prior to COVID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-0.4010±0.3103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-1.0665,0.2646)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2172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8059914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A0301D9D-7D32-4C65-7E57-291AAF52D321}"/>
              </a:ext>
            </a:extLst>
          </p:cNvPr>
          <p:cNvSpPr txBox="1"/>
          <p:nvPr/>
        </p:nvSpPr>
        <p:spPr>
          <a:xfrm>
            <a:off x="965141" y="6388591"/>
            <a:ext cx="10239406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defTabSz="91440"/>
            <a:r>
              <a:rPr lang="en-US" sz="10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SE</a:t>
            </a:r>
            <a:r>
              <a:rPr lang="en-US" sz="1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, Standard Error; </a:t>
            </a:r>
            <a:r>
              <a:rPr lang="en-US" sz="10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CI</a:t>
            </a:r>
            <a:r>
              <a:rPr lang="en-US" sz="1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, Confidence Interval; DSA, Donor Specific Antibodies. </a:t>
            </a:r>
            <a:r>
              <a:rPr lang="en-US" sz="1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+mn-ea"/>
                <a:cs typeface="Times New Roman" panose="02020603050405020304" pitchFamily="18" charset="0"/>
              </a:rPr>
              <a:t>Red bold lettered numbers in this table indicates p-value&lt;0.05.</a:t>
            </a:r>
            <a:endParaRPr lang="en-US" sz="10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7817413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719AD24B-8832-4C51-AD7F-D012379771C9}"/>
              </a:ext>
            </a:extLst>
          </p:cNvPr>
          <p:cNvSpPr txBox="1"/>
          <p:nvPr/>
        </p:nvSpPr>
        <p:spPr>
          <a:xfrm>
            <a:off x="550416" y="18033"/>
            <a:ext cx="12192000" cy="153888"/>
          </a:xfrm>
          <a:prstGeom prst="rect">
            <a:avLst/>
          </a:prstGeom>
          <a:noFill/>
        </p:spPr>
        <p:txBody>
          <a:bodyPr wrap="square" lIns="0" tIns="0" rIns="0" bIns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0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able A4b: Univariate linear regression model-based significantly altered AAbs in association with disease severity, or DSA, or time since transplant in COVID-19 LTRs</a:t>
            </a:r>
            <a:endParaRPr lang="en-US" sz="1000" b="1" dirty="0">
              <a:effectLst/>
              <a:latin typeface="Palatino Linotype" panose="0204050205050503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222A6EDF-6200-15A6-DAD8-032BF096D1D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70230540"/>
              </p:ext>
            </p:extLst>
          </p:nvPr>
        </p:nvGraphicFramePr>
        <p:xfrm>
          <a:off x="937581" y="286857"/>
          <a:ext cx="9751134" cy="602950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666556">
                  <a:extLst>
                    <a:ext uri="{9D8B030D-6E8A-4147-A177-3AD203B41FA5}">
                      <a16:colId xmlns:a16="http://schemas.microsoft.com/office/drawing/2014/main" val="2360358312"/>
                    </a:ext>
                  </a:extLst>
                </a:gridCol>
                <a:gridCol w="2484960">
                  <a:extLst>
                    <a:ext uri="{9D8B030D-6E8A-4147-A177-3AD203B41FA5}">
                      <a16:colId xmlns:a16="http://schemas.microsoft.com/office/drawing/2014/main" val="123949840"/>
                    </a:ext>
                  </a:extLst>
                </a:gridCol>
                <a:gridCol w="1799295">
                  <a:extLst>
                    <a:ext uri="{9D8B030D-6E8A-4147-A177-3AD203B41FA5}">
                      <a16:colId xmlns:a16="http://schemas.microsoft.com/office/drawing/2014/main" val="260315434"/>
                    </a:ext>
                  </a:extLst>
                </a:gridCol>
                <a:gridCol w="1483096">
                  <a:extLst>
                    <a:ext uri="{9D8B030D-6E8A-4147-A177-3AD203B41FA5}">
                      <a16:colId xmlns:a16="http://schemas.microsoft.com/office/drawing/2014/main" val="1231783432"/>
                    </a:ext>
                  </a:extLst>
                </a:gridCol>
                <a:gridCol w="677432">
                  <a:extLst>
                    <a:ext uri="{9D8B030D-6E8A-4147-A177-3AD203B41FA5}">
                      <a16:colId xmlns:a16="http://schemas.microsoft.com/office/drawing/2014/main" val="1858569581"/>
                    </a:ext>
                  </a:extLst>
                </a:gridCol>
                <a:gridCol w="639795">
                  <a:extLst>
                    <a:ext uri="{9D8B030D-6E8A-4147-A177-3AD203B41FA5}">
                      <a16:colId xmlns:a16="http://schemas.microsoft.com/office/drawing/2014/main" val="2841749830"/>
                    </a:ext>
                  </a:extLst>
                </a:gridCol>
              </a:tblGrid>
              <a:tr h="198429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Antibody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Variable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dirty="0"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Estimate ± S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96% CI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PValue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R</a:t>
                      </a:r>
                      <a:r>
                        <a:rPr lang="en-US" sz="1000" b="1" u="none" strike="noStrike" baseline="30000" dirty="0"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sz="1000" b="1" i="0" u="none" strike="noStrike" baseline="30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2088624"/>
                  </a:ext>
                </a:extLst>
              </a:tr>
              <a:tr h="66657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LKM-1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Intercept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-2.0433±1.2316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-4.6848,0.5981)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1193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3448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76894998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COVID Severe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-1.0488±1.1143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-3.4388,1.3413)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3626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04931330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Time Post Transplant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001±0.0005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-0.0010,0.0012)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8386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1838239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History of DSA Prior to COVID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.6699±1.1133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0.2821,5.0577)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310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05876077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M2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Intercept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-0.5461±0.2654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-1.1153,0.0232)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588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3791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96808335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COVID Severe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3925±0.2402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-0.1226,0.9076)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1245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05872753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Time Post Transplant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003±0.0001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0.0000,0.0005)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233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4053606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History of DSA Prior to COVID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1300±0.2399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-0.3845,0.6446)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5963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1215616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Mi-2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Intercept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-1.0586±0.4221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-1.9638,-0.1534)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251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4474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2200292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COVID Severe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8121±0.3819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-0.0070,1.6311)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517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79152096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Time Post Transplant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004±0.0002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0.0000,0.0007)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576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61982354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History of DSA Prior to COVID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3298±0.3815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-0.4885,1.1480)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4020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24897475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PM/Scl75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Intercept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-0.7934±0.3412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-1.5253,-0.0615)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356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3657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15948965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COVID Severe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4719±0.3088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-0.1903,1.1342)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1487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7086328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Time Post Transplant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003±0.0001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0.0000,0.0006)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259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98040019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History of DSA Prior to COVID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048±0.3085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-0.6568,0.6664)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9878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89113289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Scl-70/Topo Isomerase I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Intercept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-0.4874±0.2813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-1.0907,0.1158)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1051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3576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7496255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COVID Severe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1974±0.2545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-0.3484,0.7432)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4508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3032380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Time Post Transplant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002±0.0001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0.0000,0.0005)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468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0515959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History of DSA Prior to COVID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4716±0.2543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-0.0737,1.0169)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848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6140875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SmD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Intercept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-1.0571±0.5000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-2.1295,0.0152)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529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2514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19259297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COVID Severe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2979±0.4524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-0.6724,1.2683)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5208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77143087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Time Post Transplant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004±0.0002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0.0000,0.0009)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537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40644545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History of DSA Prior to COVID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1800±0.4520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-0.7894,1.1493)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6965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31901007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SRP54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Intercept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-0.8051±0.3145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-1.4798,-0.1305)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227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3394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2277126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COVID Severe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1693±0.2846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-0.4412,0.7797)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5615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08998420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Time Post Transplant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003±0.0001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0.0000,0.0006)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396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57461214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History of DSA Prior to COVID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4468±0.2843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-0.1631,1.0566)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1384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8493276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Thyroid Peroxidase (TPO)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Intercept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-1.0664±0.3340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-1.7828,-0.3501)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065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4403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11519800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COVID Severe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4961±0.3022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-0.1520,1.1443)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1229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65513104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Time Post Transplant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004±0.0001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0.0001,0.0007)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151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08454197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History of DSA Prior to COVID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4611±0.3019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-0.1865,1.1087)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1490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20000"/>
                        </a:lnSpc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8059914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E49801C0-2629-A91F-3F16-8C2410682599}"/>
              </a:ext>
            </a:extLst>
          </p:cNvPr>
          <p:cNvSpPr txBox="1"/>
          <p:nvPr/>
        </p:nvSpPr>
        <p:spPr>
          <a:xfrm>
            <a:off x="965141" y="6388591"/>
            <a:ext cx="10239406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defTabSz="91440"/>
            <a:r>
              <a:rPr lang="en-US" sz="10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SE</a:t>
            </a:r>
            <a:r>
              <a:rPr lang="en-US" sz="1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, Standard Error; </a:t>
            </a:r>
            <a:r>
              <a:rPr lang="en-US" sz="10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CI</a:t>
            </a:r>
            <a:r>
              <a:rPr lang="en-US" sz="1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, Confidence Interval; DSA, Donor Specific Antibodies. </a:t>
            </a:r>
            <a:r>
              <a:rPr lang="en-US" sz="1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+mn-ea"/>
                <a:cs typeface="Times New Roman" panose="02020603050405020304" pitchFamily="18" charset="0"/>
              </a:rPr>
              <a:t>Red bold lettered numbers in this table indicates p-value&lt;0.05.</a:t>
            </a:r>
            <a:endParaRPr lang="en-US" sz="10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963574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588</TotalTime>
  <Words>1906</Words>
  <Application>Microsoft Office PowerPoint</Application>
  <PresentationFormat>Widescreen</PresentationFormat>
  <Paragraphs>789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Palatino Linotype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dhusudhanan Narasimhan</dc:creator>
  <cp:lastModifiedBy>Ellar Wu</cp:lastModifiedBy>
  <cp:revision>96</cp:revision>
  <dcterms:created xsi:type="dcterms:W3CDTF">2022-04-08T22:19:29Z</dcterms:created>
  <dcterms:modified xsi:type="dcterms:W3CDTF">2023-10-03T01:45:14Z</dcterms:modified>
</cp:coreProperties>
</file>